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192D00-976A-4025-B5E5-F97C600364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E6712-56BB-4F6D-9088-532FCD2BEA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EC5F45-64F5-4D53-9108-06C24698B8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2E4E8-ABC2-4D6D-A4C3-D4E52642EB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256B3-99FD-4C5F-984A-72C8F45444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2751A-70DD-4FE2-9486-084E9A6859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574A6-7776-4A27-875B-E0AC3DC4C8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6580B-5F2A-4C82-86BB-A864A018C0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8C329-E4A5-4777-9A91-5245402D6B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0102B1-0A5C-4CF0-9560-63835C7321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42DDBD-7683-4E97-9CAF-EA03157AAF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DD98A-6799-4F46-A260-0CFA633DE2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48ACB4-F32E-44BF-9711-00E72E8A00C6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"/>
          <p:cNvGrpSpPr/>
          <p:nvPr/>
        </p:nvGrpSpPr>
        <p:grpSpPr>
          <a:xfrm>
            <a:off x="2658960" y="406440"/>
            <a:ext cx="6207120" cy="1589040"/>
            <a:chOff x="2658960" y="406440"/>
            <a:chExt cx="6207120" cy="1589040"/>
          </a:xfrm>
        </p:grpSpPr>
        <p:sp>
          <p:nvSpPr>
            <p:cNvPr id="42" name="Rectangle 4"/>
            <p:cNvSpPr/>
            <p:nvPr/>
          </p:nvSpPr>
          <p:spPr>
            <a:xfrm>
              <a:off x="2658960" y="406440"/>
              <a:ext cx="6207120" cy="1589040"/>
            </a:xfrm>
            <a:prstGeom prst="roundRect">
              <a:avLst>
                <a:gd name="adj" fmla="val 16667"/>
              </a:avLst>
            </a:prstGeom>
            <a:solidFill>
              <a:srgbClr val="a5a5a5"/>
            </a:solidFill>
            <a:ln w="12600">
              <a:solidFill>
                <a:srgbClr val="78787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TextBox 5"/>
            <p:cNvSpPr/>
            <p:nvPr/>
          </p:nvSpPr>
          <p:spPr>
            <a:xfrm>
              <a:off x="3749400" y="482400"/>
              <a:ext cx="3684600" cy="30600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12600">
              <a:solidFill>
                <a:srgbClr val="a5a5a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sponse: Methylation Predictor: Visceral Fa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4" name="Rectangle: Rounded Corners 17"/>
          <p:cNvSpPr/>
          <p:nvPr/>
        </p:nvSpPr>
        <p:spPr>
          <a:xfrm>
            <a:off x="79200" y="2843280"/>
            <a:ext cx="2656080" cy="3795480"/>
          </a:xfrm>
          <a:custGeom>
            <a:avLst/>
            <a:gdLst>
              <a:gd name="textAreaLeft" fmla="*/ 129600 w 2656080"/>
              <a:gd name="textAreaRight" fmla="*/ 2526480 w 2656080"/>
              <a:gd name="textAreaTop" fmla="*/ 129600 h 3795480"/>
              <a:gd name="textAreaBottom" fmla="*/ 3665880 h 3795480"/>
            </a:gdLst>
            <a:ahLst/>
            <a:rect l="textAreaLeft" t="textAreaTop" r="textAreaRight" b="textAreaBottom"/>
            <a:pathLst>
              <a:path w="21600" h="30865">
                <a:moveTo>
                  <a:pt x="3600" y="0"/>
                </a:moveTo>
                <a:arcTo wR="3600" hR="3600" stAng="16200000" swAng="-5400000"/>
                <a:lnTo>
                  <a:pt x="0" y="27265"/>
                </a:lnTo>
                <a:arcTo wR="3600" hR="3600" stAng="10800000" swAng="-5400000"/>
                <a:lnTo>
                  <a:pt x="18000" y="30865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a5a5a5"/>
          </a:solidFill>
          <a:ln w="12600">
            <a:solidFill>
              <a:srgbClr val="78787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: Rounded Corners 18"/>
          <p:cNvSpPr/>
          <p:nvPr/>
        </p:nvSpPr>
        <p:spPr>
          <a:xfrm>
            <a:off x="79200" y="3408480"/>
            <a:ext cx="2630520" cy="7063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Methylation Predictor: Genetic vari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38 TwinsU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variates: Age, Smoking, PCs, Famil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: Rounded Corners 19"/>
          <p:cNvSpPr/>
          <p:nvPr/>
        </p:nvSpPr>
        <p:spPr>
          <a:xfrm>
            <a:off x="88920" y="4176720"/>
            <a:ext cx="2620800" cy="98424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Expression Predictor: Genetic vari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700 TwinsUK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variates:</a:t>
            </a:r>
            <a:r>
              <a:rPr b="0" lang="en-GB" sz="1000" spc="-1" strike="noStrike">
                <a:solidFill>
                  <a:srgbClr val="ffffff"/>
                </a:solidFill>
                <a:latin typeface="Arial"/>
                <a:ea typeface="Arial"/>
              </a:rPr>
              <a:t>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MI, Age, Smoking, Cell Type, Zygosity, Family, sequencing date, insert size, GC content, primer index, batc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ctangle: Rounded Corners 27"/>
          <p:cNvSpPr/>
          <p:nvPr/>
        </p:nvSpPr>
        <p:spPr>
          <a:xfrm>
            <a:off x="2798640" y="2860560"/>
            <a:ext cx="2144880" cy="3270240"/>
          </a:xfrm>
          <a:custGeom>
            <a:avLst/>
            <a:gdLst>
              <a:gd name="textAreaLeft" fmla="*/ 104400 w 2144880"/>
              <a:gd name="textAreaRight" fmla="*/ 2040480 w 2144880"/>
              <a:gd name="textAreaTop" fmla="*/ 104400 h 3270240"/>
              <a:gd name="textAreaBottom" fmla="*/ 3165840 h 3270240"/>
            </a:gdLst>
            <a:ahLst/>
            <a:rect l="textAreaLeft" t="textAreaTop" r="textAreaRight" b="textAreaBottom"/>
            <a:pathLst>
              <a:path w="21600" h="32931">
                <a:moveTo>
                  <a:pt x="3600" y="0"/>
                </a:moveTo>
                <a:arcTo wR="3600" hR="3600" stAng="16200000" swAng="-5400000"/>
                <a:lnTo>
                  <a:pt x="0" y="29331"/>
                </a:lnTo>
                <a:arcTo wR="3600" hR="3600" stAng="10800000" swAng="-5400000"/>
                <a:lnTo>
                  <a:pt x="18000" y="32931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a5a5a5"/>
          </a:solidFill>
          <a:ln w="12600">
            <a:solidFill>
              <a:srgbClr val="78787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linical Phenotyp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: Rounded Corners 31"/>
          <p:cNvSpPr/>
          <p:nvPr/>
        </p:nvSpPr>
        <p:spPr>
          <a:xfrm>
            <a:off x="2846520" y="3251160"/>
            <a:ext cx="2041560" cy="12654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Insulin Resistanc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14 IR cases 284 Contro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Response: Methylation Predictor: I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variates: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BMI, Age, Smoking, Cell Type, Chip/Position, Zygosity, Famil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40"/>
          <p:cNvSpPr/>
          <p:nvPr/>
        </p:nvSpPr>
        <p:spPr>
          <a:xfrm>
            <a:off x="1019160" y="2451240"/>
            <a:ext cx="115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Genetic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45"/>
          <p:cNvSpPr/>
          <p:nvPr/>
        </p:nvSpPr>
        <p:spPr>
          <a:xfrm>
            <a:off x="10395000" y="2400480"/>
            <a:ext cx="2352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Die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1" name="Straight Arrow Connector 62"/>
          <p:cNvCxnSpPr/>
          <p:nvPr/>
        </p:nvCxnSpPr>
        <p:spPr>
          <a:xfrm flipH="1">
            <a:off x="10398960" y="3678120"/>
            <a:ext cx="2520" cy="239040"/>
          </a:xfrm>
          <a:prstGeom prst="straightConnector1">
            <a:avLst/>
          </a:prstGeom>
          <a:ln w="6480">
            <a:solidFill>
              <a:srgbClr val="4472c4"/>
            </a:solidFill>
            <a:miter/>
            <a:tailEnd len="med" type="triangle" w="med"/>
          </a:ln>
        </p:spPr>
      </p:cxnSp>
      <p:sp>
        <p:nvSpPr>
          <p:cNvPr id="52" name="TextBox 72"/>
          <p:cNvSpPr/>
          <p:nvPr/>
        </p:nvSpPr>
        <p:spPr>
          <a:xfrm>
            <a:off x="4830840" y="2454120"/>
            <a:ext cx="258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Metabolic Phenotyp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traight Connector 25"/>
          <p:cNvSpPr/>
          <p:nvPr/>
        </p:nvSpPr>
        <p:spPr>
          <a:xfrm>
            <a:off x="1743120" y="2179800"/>
            <a:ext cx="9039240" cy="0"/>
          </a:xfrm>
          <a:prstGeom prst="line">
            <a:avLst/>
          </a:prstGeom>
          <a:ln w="255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Straight Arrow Connector 41"/>
          <p:cNvCxnSpPr/>
          <p:nvPr/>
        </p:nvCxnSpPr>
        <p:spPr>
          <a:xfrm>
            <a:off x="1742760" y="2179440"/>
            <a:ext cx="1080" cy="270360"/>
          </a:xfrm>
          <a:prstGeom prst="straightConnector1">
            <a:avLst/>
          </a:prstGeom>
          <a:ln w="25560">
            <a:solidFill>
              <a:srgbClr val="4472c4"/>
            </a:solidFill>
            <a:miter/>
            <a:tailEnd len="med" type="triangle" w="med"/>
          </a:ln>
        </p:spPr>
      </p:cxnSp>
      <p:cxnSp>
        <p:nvCxnSpPr>
          <p:cNvPr id="55" name="Straight Arrow Connector 43"/>
          <p:cNvCxnSpPr/>
          <p:nvPr/>
        </p:nvCxnSpPr>
        <p:spPr>
          <a:xfrm>
            <a:off x="5949720" y="2197080"/>
            <a:ext cx="1080" cy="240480"/>
          </a:xfrm>
          <a:prstGeom prst="straightConnector1">
            <a:avLst/>
          </a:prstGeom>
          <a:ln w="25560">
            <a:solidFill>
              <a:srgbClr val="4472c4"/>
            </a:solidFill>
            <a:miter/>
            <a:tailEnd len="med" type="triangle" w="med"/>
          </a:ln>
        </p:spPr>
      </p:cxnSp>
      <p:cxnSp>
        <p:nvCxnSpPr>
          <p:cNvPr id="56" name="Straight Arrow Connector 50"/>
          <p:cNvCxnSpPr/>
          <p:nvPr/>
        </p:nvCxnSpPr>
        <p:spPr>
          <a:xfrm>
            <a:off x="10782000" y="2179440"/>
            <a:ext cx="1080" cy="270360"/>
          </a:xfrm>
          <a:prstGeom prst="straightConnector1">
            <a:avLst/>
          </a:prstGeom>
          <a:ln w="25560">
            <a:solidFill>
              <a:srgbClr val="4472c4"/>
            </a:solidFill>
            <a:miter/>
            <a:tailEnd len="med" type="triangle" w="med"/>
          </a:ln>
        </p:spPr>
      </p:cxnSp>
      <p:sp>
        <p:nvSpPr>
          <p:cNvPr id="57" name="Rectangle: Rounded Corners 73"/>
          <p:cNvSpPr/>
          <p:nvPr/>
        </p:nvSpPr>
        <p:spPr>
          <a:xfrm>
            <a:off x="5040360" y="2849400"/>
            <a:ext cx="2154240" cy="3418200"/>
          </a:xfrm>
          <a:custGeom>
            <a:avLst/>
            <a:gdLst>
              <a:gd name="textAreaLeft" fmla="*/ 105120 w 2154240"/>
              <a:gd name="textAreaRight" fmla="*/ 2049120 w 2154240"/>
              <a:gd name="textAreaTop" fmla="*/ 105120 h 3418200"/>
              <a:gd name="textAreaBottom" fmla="*/ 3313080 h 3418200"/>
            </a:gdLst>
            <a:ahLst/>
            <a:rect l="textAreaLeft" t="textAreaTop" r="textAreaRight" b="textAreaBottom"/>
            <a:pathLst>
              <a:path w="21600" h="34271">
                <a:moveTo>
                  <a:pt x="3600" y="0"/>
                </a:moveTo>
                <a:arcTo wR="3600" hR="3600" stAng="16200000" swAng="-5400000"/>
                <a:lnTo>
                  <a:pt x="0" y="30671"/>
                </a:lnTo>
                <a:arcTo wR="3600" hR="3600" stAng="10800000" swAng="-5400000"/>
                <a:lnTo>
                  <a:pt x="18000" y="34271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a5a5a5"/>
          </a:solidFill>
          <a:ln w="12600">
            <a:solidFill>
              <a:srgbClr val="78787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Lipid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: Rounded Corners 76"/>
          <p:cNvSpPr/>
          <p:nvPr/>
        </p:nvSpPr>
        <p:spPr>
          <a:xfrm>
            <a:off x="5079960" y="3246480"/>
            <a:ext cx="2062080" cy="2925720"/>
          </a:xfrm>
          <a:custGeom>
            <a:avLst/>
            <a:gdLst>
              <a:gd name="textAreaLeft" fmla="*/ 100440 w 2062080"/>
              <a:gd name="textAreaRight" fmla="*/ 1961640 w 2062080"/>
              <a:gd name="textAreaTop" fmla="*/ 100440 h 2925720"/>
              <a:gd name="textAreaBottom" fmla="*/ 2825280 h 2925720"/>
            </a:gdLst>
            <a:ahLst/>
            <a:rect l="textAreaLeft" t="textAreaTop" r="textAreaRight" b="textAreaBottom"/>
            <a:pathLst>
              <a:path w="21600" h="30645">
                <a:moveTo>
                  <a:pt x="3600" y="0"/>
                </a:moveTo>
                <a:arcTo wR="3600" hR="3600" stAng="16200000" swAng="-5400000"/>
                <a:lnTo>
                  <a:pt x="0" y="27045"/>
                </a:lnTo>
                <a:arcTo wR="3600" hR="3600" stAng="10800000" swAng="-5400000"/>
                <a:lnTo>
                  <a:pt x="18000" y="30645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Methylation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redictor: HDL/TG/TC/LD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28 TwinsU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variates: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BMI, Age, Smoking, Cell Type, Chip/Position, Zygosity, Famil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Methylation Predictor: Further Lipid Metabolit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47 TwinsU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variates: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BMI, Age, Smoking, Cell Type, Chip/Position, Zygosity, Famil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: Rounded Corners 78"/>
          <p:cNvSpPr/>
          <p:nvPr/>
        </p:nvSpPr>
        <p:spPr>
          <a:xfrm>
            <a:off x="7284960" y="2841480"/>
            <a:ext cx="2247840" cy="1908360"/>
          </a:xfrm>
          <a:prstGeom prst="roundRect">
            <a:avLst>
              <a:gd name="adj" fmla="val 16667"/>
            </a:avLst>
          </a:prstGeom>
          <a:solidFill>
            <a:srgbClr val="a5a5a5"/>
          </a:solidFill>
          <a:ln w="12600">
            <a:solidFill>
              <a:srgbClr val="78787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Amino Acid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: Rounded Corners 87"/>
          <p:cNvSpPr/>
          <p:nvPr/>
        </p:nvSpPr>
        <p:spPr>
          <a:xfrm>
            <a:off x="326880" y="6172200"/>
            <a:ext cx="2035440" cy="45864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endelian Randomis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38 TwinsU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: Rounded Corners 90"/>
          <p:cNvSpPr/>
          <p:nvPr/>
        </p:nvSpPr>
        <p:spPr>
          <a:xfrm>
            <a:off x="9605880" y="2819520"/>
            <a:ext cx="2497320" cy="1511280"/>
          </a:xfrm>
          <a:prstGeom prst="roundRect">
            <a:avLst>
              <a:gd name="adj" fmla="val 16667"/>
            </a:avLst>
          </a:prstGeom>
          <a:solidFill>
            <a:srgbClr val="a5a5a5"/>
          </a:solidFill>
          <a:ln w="12600">
            <a:solidFill>
              <a:srgbClr val="78787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: Rounded Corners 91"/>
          <p:cNvSpPr/>
          <p:nvPr/>
        </p:nvSpPr>
        <p:spPr>
          <a:xfrm>
            <a:off x="9750600" y="2944800"/>
            <a:ext cx="2180880" cy="12319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Methylation Predictors: Diet Variabl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97 TwinsU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variates: BMI, Age, Smoking, Cell Type, Chip/Position, Zygosity, Famil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05"/>
          <p:cNvSpPr/>
          <p:nvPr/>
        </p:nvSpPr>
        <p:spPr>
          <a:xfrm>
            <a:off x="3568680" y="54000"/>
            <a:ext cx="583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Epigenome-wide Analysis in Adipose Tiss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: Rounded Corners 61"/>
          <p:cNvSpPr/>
          <p:nvPr/>
        </p:nvSpPr>
        <p:spPr>
          <a:xfrm>
            <a:off x="441360" y="2944800"/>
            <a:ext cx="1995480" cy="36684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Heritability (ACE model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38 TwinsUK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71"/>
          <p:cNvSpPr/>
          <p:nvPr/>
        </p:nvSpPr>
        <p:spPr>
          <a:xfrm>
            <a:off x="3665520" y="1152360"/>
            <a:ext cx="4005360" cy="3060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a5a5a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Gene Expression Predictor: Visceral F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81"/>
          <p:cNvSpPr/>
          <p:nvPr/>
        </p:nvSpPr>
        <p:spPr>
          <a:xfrm>
            <a:off x="2797200" y="846000"/>
            <a:ext cx="5965920" cy="27216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a5a5a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38 TwinsUK Covariates: BMI, Age, Smoking, Cell Type, Chip/Position, Zygosity, Famil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7" name="Straight Arrow Connector 82"/>
          <p:cNvCxnSpPr/>
          <p:nvPr/>
        </p:nvCxnSpPr>
        <p:spPr>
          <a:xfrm>
            <a:off x="5944680" y="1925640"/>
            <a:ext cx="1080" cy="240480"/>
          </a:xfrm>
          <a:prstGeom prst="straightConnector1">
            <a:avLst/>
          </a:prstGeom>
          <a:ln w="25560">
            <a:solidFill>
              <a:srgbClr val="4472c4"/>
            </a:solidFill>
            <a:miter/>
          </a:ln>
        </p:spPr>
      </p:cxnSp>
      <p:sp>
        <p:nvSpPr>
          <p:cNvPr id="68" name="Rectangle: Rounded Corners 69"/>
          <p:cNvSpPr/>
          <p:nvPr/>
        </p:nvSpPr>
        <p:spPr>
          <a:xfrm>
            <a:off x="7203960" y="5219640"/>
            <a:ext cx="4899240" cy="1559160"/>
          </a:xfrm>
          <a:prstGeom prst="roundRect">
            <a:avLst>
              <a:gd name="adj" fmla="val 16667"/>
            </a:avLst>
          </a:prstGeom>
          <a:solidFill>
            <a:srgbClr val="a5a5a5"/>
          </a:solidFill>
          <a:ln w="12600">
            <a:solidFill>
              <a:srgbClr val="78787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70"/>
          <p:cNvSpPr/>
          <p:nvPr/>
        </p:nvSpPr>
        <p:spPr>
          <a:xfrm>
            <a:off x="7790040" y="4857840"/>
            <a:ext cx="414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Replication of 19 Multi-omic VF-DMP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: Rounded Corners 83"/>
          <p:cNvSpPr/>
          <p:nvPr/>
        </p:nvSpPr>
        <p:spPr>
          <a:xfrm>
            <a:off x="7281720" y="5302080"/>
            <a:ext cx="4743720" cy="4525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ype 2 Diabetes Wilcoxon T-Tes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28 T2D 28 controls Danish Twin Registr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64"/>
          <p:cNvSpPr/>
          <p:nvPr/>
        </p:nvSpPr>
        <p:spPr>
          <a:xfrm>
            <a:off x="3613320" y="1494000"/>
            <a:ext cx="4146480" cy="4410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a5a5a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700 TwinsUK Covariates: BMI, Age, Smoking, Cell Type, Zygosity, Family, sequencing date, insert size, GC content, primer index, batc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: Rounded Corners 40"/>
          <p:cNvSpPr/>
          <p:nvPr/>
        </p:nvSpPr>
        <p:spPr>
          <a:xfrm>
            <a:off x="81000" y="5184720"/>
            <a:ext cx="2654280" cy="94608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Gene Expression Predictor: Methy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38 TwinsUK Covariates: BMI, Age, Smoking, Cell Type, Chip/Position, Zygosity, Family, sequencing date, insert size, GC content, primer index, batc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: Rounded Corners 42"/>
          <p:cNvSpPr/>
          <p:nvPr/>
        </p:nvSpPr>
        <p:spPr>
          <a:xfrm>
            <a:off x="2825640" y="4565520"/>
            <a:ext cx="2043360" cy="12654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ype 2 Diabet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5 T2D 378 Contro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Response: Methylation Predictor: T2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variates: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BMI, Age, Smoking, Cell Type, Chip/Position, Zygosity, Famil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: Rounded Corners 44"/>
          <p:cNvSpPr/>
          <p:nvPr/>
        </p:nvSpPr>
        <p:spPr>
          <a:xfrm>
            <a:off x="7332840" y="3281400"/>
            <a:ext cx="2152440" cy="12049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Methylation Predictor: Amino Aci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47 TwinsU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variates: BMI, Age, Smoking, Cell Type, Chip/Position, Zygosity, Famil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ctangle: Rounded Corners 45"/>
          <p:cNvSpPr/>
          <p:nvPr/>
        </p:nvSpPr>
        <p:spPr>
          <a:xfrm>
            <a:off x="9464760" y="741240"/>
            <a:ext cx="2352600" cy="94788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Methylation Predictor: AG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Calibri"/>
              </a:rPr>
              <a:t>104 LEAP cohor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Calibri"/>
              </a:rPr>
              <a:t>Covariates: age, sex, smoking status, BMI and batch effec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70"/>
          <p:cNvSpPr/>
          <p:nvPr/>
        </p:nvSpPr>
        <p:spPr>
          <a:xfrm>
            <a:off x="9988560" y="371520"/>
            <a:ext cx="130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Valida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7" name="Straight Arrow Connector 47"/>
          <p:cNvCxnSpPr/>
          <p:nvPr/>
        </p:nvCxnSpPr>
        <p:spPr>
          <a:xfrm>
            <a:off x="8992800" y="1152000"/>
            <a:ext cx="408600" cy="1080"/>
          </a:xfrm>
          <a:prstGeom prst="straightConnector1">
            <a:avLst/>
          </a:prstGeom>
          <a:ln w="25560">
            <a:solidFill>
              <a:srgbClr val="4472c4"/>
            </a:solidFill>
            <a:miter/>
            <a:tailEnd len="med" type="triangle" w="med"/>
          </a:ln>
        </p:spPr>
      </p:cxnSp>
      <p:sp>
        <p:nvSpPr>
          <p:cNvPr id="78" name="Rectangle: Rounded Corners 48"/>
          <p:cNvSpPr/>
          <p:nvPr/>
        </p:nvSpPr>
        <p:spPr>
          <a:xfrm>
            <a:off x="7281720" y="5837400"/>
            <a:ext cx="4743720" cy="87444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esponse: Methy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redictor: Lipid levels (TG/HDL/T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199 Quebec Heart and Lung Covariates: age, sex, batch effects and BM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Rectangle: Rounded Corners 87"/>
          <p:cNvSpPr/>
          <p:nvPr/>
        </p:nvSpPr>
        <p:spPr>
          <a:xfrm>
            <a:off x="3362400" y="5864400"/>
            <a:ext cx="969840" cy="23652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winsU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"/>
          <p:cNvSpPr/>
          <p:nvPr/>
        </p:nvSpPr>
        <p:spPr>
          <a:xfrm>
            <a:off x="326880" y="257040"/>
            <a:ext cx="78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Fig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Picture 3" descr=""/>
          <p:cNvPicPr/>
          <p:nvPr/>
        </p:nvPicPr>
        <p:blipFill>
          <a:blip r:embed="rId1"/>
          <a:stretch/>
        </p:blipFill>
        <p:spPr>
          <a:xfrm>
            <a:off x="6588000" y="1185840"/>
            <a:ext cx="4572000" cy="4572000"/>
          </a:xfrm>
          <a:prstGeom prst="rect">
            <a:avLst/>
          </a:prstGeom>
          <a:ln w="0">
            <a:noFill/>
          </a:ln>
        </p:spPr>
      </p:pic>
      <p:sp>
        <p:nvSpPr>
          <p:cNvPr id="82" name="Rectangle 4"/>
          <p:cNvSpPr/>
          <p:nvPr/>
        </p:nvSpPr>
        <p:spPr>
          <a:xfrm>
            <a:off x="7553160" y="5896080"/>
            <a:ext cx="276480" cy="95040"/>
          </a:xfrm>
          <a:prstGeom prst="rect">
            <a:avLst/>
          </a:prstGeom>
          <a:solidFill>
            <a:srgbClr val="2f5597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tangle 5"/>
          <p:cNvSpPr/>
          <p:nvPr/>
        </p:nvSpPr>
        <p:spPr>
          <a:xfrm>
            <a:off x="7553160" y="6105600"/>
            <a:ext cx="276480" cy="95040"/>
          </a:xfrm>
          <a:prstGeom prst="rect">
            <a:avLst/>
          </a:prstGeom>
          <a:solidFill>
            <a:srgbClr val="cc0000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6"/>
          <p:cNvSpPr/>
          <p:nvPr/>
        </p:nvSpPr>
        <p:spPr>
          <a:xfrm>
            <a:off x="7905600" y="5811840"/>
            <a:ext cx="261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ignificant at Multiple test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7"/>
          <p:cNvSpPr/>
          <p:nvPr/>
        </p:nvSpPr>
        <p:spPr>
          <a:xfrm>
            <a:off x="7915320" y="6021360"/>
            <a:ext cx="3419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ignificant at Multiple testing with Full Medi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8"/>
          <p:cNvSpPr/>
          <p:nvPr/>
        </p:nvSpPr>
        <p:spPr>
          <a:xfrm>
            <a:off x="7553160" y="6305400"/>
            <a:ext cx="276480" cy="95400"/>
          </a:xfrm>
          <a:prstGeom prst="rect">
            <a:avLst/>
          </a:prstGeom>
          <a:solidFill>
            <a:srgbClr val="dbdbdb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9"/>
          <p:cNvSpPr/>
          <p:nvPr/>
        </p:nvSpPr>
        <p:spPr>
          <a:xfrm>
            <a:off x="7924680" y="6202440"/>
            <a:ext cx="261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Nominally significa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8" name="Picture 10" descr=""/>
          <p:cNvPicPr/>
          <p:nvPr/>
        </p:nvPicPr>
        <p:blipFill>
          <a:blip r:embed="rId2"/>
          <a:stretch/>
        </p:blipFill>
        <p:spPr>
          <a:xfrm>
            <a:off x="1319040" y="1666800"/>
            <a:ext cx="3249720" cy="3249720"/>
          </a:xfrm>
          <a:prstGeom prst="rect">
            <a:avLst/>
          </a:prstGeom>
          <a:ln w="0">
            <a:noFill/>
          </a:ln>
        </p:spPr>
      </p:pic>
      <p:sp>
        <p:nvSpPr>
          <p:cNvPr id="89" name="TextBox 1"/>
          <p:cNvSpPr/>
          <p:nvPr/>
        </p:nvSpPr>
        <p:spPr>
          <a:xfrm>
            <a:off x="372960" y="338040"/>
            <a:ext cx="123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Fig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11"/>
          <p:cNvSpPr/>
          <p:nvPr/>
        </p:nvSpPr>
        <p:spPr>
          <a:xfrm>
            <a:off x="6249960" y="304920"/>
            <a:ext cx="88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Fig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Box 2"/>
          <p:cNvSpPr/>
          <p:nvPr/>
        </p:nvSpPr>
        <p:spPr>
          <a:xfrm>
            <a:off x="372960" y="33804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Fig 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2" name="Picture 4" descr="Chart, scatter chart&#10;&#10;Description automatically generated"/>
          <p:cNvPicPr/>
          <p:nvPr/>
        </p:nvPicPr>
        <p:blipFill>
          <a:blip r:embed="rId1"/>
          <a:stretch/>
        </p:blipFill>
        <p:spPr>
          <a:xfrm>
            <a:off x="826920" y="806400"/>
            <a:ext cx="4572000" cy="457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Graphic 4" descr=""/>
          <p:cNvPicPr/>
          <p:nvPr/>
        </p:nvPicPr>
        <p:blipFill>
          <a:blip r:embed="rId1"/>
          <a:stretch/>
        </p:blipFill>
        <p:spPr>
          <a:xfrm>
            <a:off x="2716200" y="0"/>
            <a:ext cx="3828960" cy="6858000"/>
          </a:xfrm>
          <a:prstGeom prst="rect">
            <a:avLst/>
          </a:prstGeom>
          <a:ln w="0">
            <a:noFill/>
          </a:ln>
        </p:spPr>
      </p:pic>
      <p:pic>
        <p:nvPicPr>
          <p:cNvPr id="94" name="Graphic 6" descr=""/>
          <p:cNvPicPr/>
          <p:nvPr/>
        </p:nvPicPr>
        <p:blipFill>
          <a:blip r:embed="rId2"/>
          <a:stretch/>
        </p:blipFill>
        <p:spPr>
          <a:xfrm>
            <a:off x="6323040" y="119160"/>
            <a:ext cx="4143240" cy="6619680"/>
          </a:xfrm>
          <a:prstGeom prst="rect">
            <a:avLst/>
          </a:prstGeom>
          <a:ln w="0">
            <a:noFill/>
          </a:ln>
        </p:spPr>
      </p:pic>
      <p:sp>
        <p:nvSpPr>
          <p:cNvPr id="95" name="TextBox 7"/>
          <p:cNvSpPr/>
          <p:nvPr/>
        </p:nvSpPr>
        <p:spPr>
          <a:xfrm>
            <a:off x="603360" y="407880"/>
            <a:ext cx="83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Fig S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5-18T11:31:54Z</dcterms:created>
  <dc:creator>Christiansen, Colette</dc:creator>
  <dc:description/>
  <dc:language>en-US</dc:language>
  <cp:lastModifiedBy>Christiansen, Colette</cp:lastModifiedBy>
  <dcterms:modified xsi:type="dcterms:W3CDTF">2022-06-03T14:36:34Z</dcterms:modified>
  <cp:revision>31</cp:revision>
  <dc:subject/>
  <dc:title>PowerPoint Presentation</dc:title>
</cp:coreProperties>
</file>